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735763" cy="9866313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9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2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276" y="84"/>
      </p:cViewPr>
      <p:guideLst>
        <p:guide orient="horz" pos="3097"/>
        <p:guide pos="9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66F0E7-FD15-4EE7-BE7E-B91504887E1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5C57E6-2FC1-4B7F-A9C1-B7C3BF2B536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06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77C0C4-86BD-44AA-BA48-532F3CE388A5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5560C63-0E5F-4F79-9E19-8EDA44005DCA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7421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7B5FDA-F372-48DD-8C3C-370C9015FCF9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1489A9E-3EB9-4DB6-87D4-E740B71B8816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7998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C0D9D5-3A67-4F9A-B958-5F084B9A1776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34AF34-1DC5-4FAE-A874-2AFC6626EFC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2877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361E0F-CBB6-4295-BEF5-8D6CEFAAD7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64C392-1ABB-401C-9E09-E0F4E77A4BA7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226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9371B6-4E15-474F-BEF5-8DF1A0CC3F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7DBF49-C2EE-4243-9DDA-ECACE02EE4F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529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D3B6B8-3310-42C8-9503-82E0DD06A17C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82C61DC-EF6C-42CF-A95F-5EA824D88A5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6826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E2FFB8-10C3-4DDC-BFB1-F5DA96EF200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B3A4582-A24B-43AE-8848-B28F27B1CA3D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486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1840C8-D884-4585-AE4B-8A84B519972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117750D-E422-4FA2-8A8E-9F144631D8F0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82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DEA246-8415-4F73-B506-4EF236446FB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9242D4-7F37-4765-8228-AFFD464C80CC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432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A1402F-2B5F-41A6-A9E1-308A4E1683E7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AACC69-91FE-4395-AD7C-3667926C054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59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  <a:endParaRPr lang="en-US" altLang="ko-KR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altLang="ko-KR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E52F96B-E043-4EF3-850C-A79CC90021C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kumimoji="0" sz="900">
                <a:solidFill>
                  <a:srgbClr val="898989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</a:lstStyle>
          <a:p>
            <a:fld id="{C31CD9A6-5F9B-407A-AD78-81B512AE21E6}" type="slidenum">
              <a:rPr lang="ko-KR" altLang="en-US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2pPr>
      <a:lvl3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3pPr>
      <a:lvl4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4pPr>
      <a:lvl5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5pPr>
      <a:lvl6pPr marL="4572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6pPr>
      <a:lvl7pPr marL="9144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7pPr>
      <a:lvl8pPr marL="13716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8pPr>
      <a:lvl9pPr marL="18288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9pPr>
    </p:titleStyle>
    <p:bodyStyle>
      <a:lvl1pPr marL="171450" indent="-171450" algn="l" defTabSz="685800" rtl="0" eaLnBrk="0" fontAlgn="base" latinLnBrk="1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직선 연결선 2"/>
          <p:cNvCxnSpPr/>
          <p:nvPr/>
        </p:nvCxnSpPr>
        <p:spPr>
          <a:xfrm>
            <a:off x="1650931" y="3253052"/>
            <a:ext cx="9144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" name="직선 연결선 3"/>
          <p:cNvCxnSpPr/>
          <p:nvPr/>
        </p:nvCxnSpPr>
        <p:spPr>
          <a:xfrm>
            <a:off x="2621606" y="3253052"/>
            <a:ext cx="9144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직선 연결선 4"/>
          <p:cNvCxnSpPr/>
          <p:nvPr/>
        </p:nvCxnSpPr>
        <p:spPr>
          <a:xfrm>
            <a:off x="3638622" y="3253052"/>
            <a:ext cx="9144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" name="직선 연결선 5"/>
          <p:cNvCxnSpPr/>
          <p:nvPr/>
        </p:nvCxnSpPr>
        <p:spPr>
          <a:xfrm>
            <a:off x="4655638" y="3253052"/>
            <a:ext cx="9144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647267" y="329985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38 WT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69363" y="3300867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38 KO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50514" y="3311027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38 WT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672610" y="3287659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D38 KO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개체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3065322"/>
              </p:ext>
            </p:extLst>
          </p:nvPr>
        </p:nvGraphicFramePr>
        <p:xfrm>
          <a:off x="1559585" y="2202032"/>
          <a:ext cx="4084922" cy="382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3" name="Image" r:id="rId3" imgW="5612400" imgH="533160" progId="Photoshop.Image.13">
                  <p:embed/>
                </p:oleObj>
              </mc:Choice>
              <mc:Fallback>
                <p:oleObj name="Image" r:id="rId3" imgW="5612400" imgH="5331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>
                        <a:lum bright="-20000" contrast="20000"/>
                      </a:blip>
                      <a:stretch>
                        <a:fillRect/>
                      </a:stretch>
                    </p:blipFill>
                    <p:spPr>
                      <a:xfrm>
                        <a:off x="1559585" y="2202032"/>
                        <a:ext cx="4084922" cy="38267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개체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6193097"/>
              </p:ext>
            </p:extLst>
          </p:nvPr>
        </p:nvGraphicFramePr>
        <p:xfrm>
          <a:off x="1559585" y="1661864"/>
          <a:ext cx="4084922" cy="3863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4" name="Image" r:id="rId5" imgW="5968080" imgH="647280" progId="Photoshop.Image.13">
                  <p:embed/>
                </p:oleObj>
              </mc:Choice>
              <mc:Fallback>
                <p:oleObj name="Image" r:id="rId5" imgW="5968080" imgH="6472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59585" y="1661864"/>
                        <a:ext cx="4084922" cy="386391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822293" y="1701170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4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β</a:t>
            </a:r>
            <a:r>
              <a:rPr lang="en-US" altLang="ko-KR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AR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22292" y="2274177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4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β</a:t>
            </a:r>
            <a:r>
              <a:rPr lang="en-US" altLang="ko-KR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AR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647267" y="1438656"/>
            <a:ext cx="188873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311751" y="1076195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3650514" y="1434414"/>
            <a:ext cx="188873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314998" y="1071953"/>
            <a:ext cx="5389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SO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582132" y="3968200"/>
            <a:ext cx="585825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1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S2 Fig. Expression of </a:t>
            </a:r>
            <a:r>
              <a:rPr lang="el-GR" altLang="ko-KR" sz="11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β</a:t>
            </a:r>
            <a:r>
              <a:rPr lang="en-US" altLang="ko-KR" sz="11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1-adrenalnergic receptor (AR) and </a:t>
            </a:r>
            <a:r>
              <a:rPr lang="el-GR" altLang="ko-KR" sz="11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β</a:t>
            </a:r>
            <a:r>
              <a:rPr lang="en-US" altLang="ko-KR" sz="11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2-AR in ISO-treated CD38 wild type (WT) and CD38 knockout (KO) mice heart. </a:t>
            </a:r>
            <a:r>
              <a:rPr lang="en-US" altLang="ko-KR" sz="1100" kern="100" dirty="0">
                <a:latin typeface="Times New Roman" panose="02020603050405020304" pitchFamily="18" charset="0"/>
                <a:ea typeface="바탕체" panose="02030609000101010101" pitchFamily="17" charset="-127"/>
              </a:rPr>
              <a:t>Heart were isolated and analyzed for protein expression </a:t>
            </a:r>
            <a:r>
              <a:rPr lang="en-US" altLang="ko-KR" sz="1100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before (Con) and following </a:t>
            </a:r>
            <a:r>
              <a:rPr lang="en-US" altLang="ko-KR" sz="1100" kern="100" dirty="0">
                <a:latin typeface="Times New Roman" panose="02020603050405020304" pitchFamily="18" charset="0"/>
                <a:ea typeface="바탕체" panose="02030609000101010101" pitchFamily="17" charset="-127"/>
              </a:rPr>
              <a:t>7 days of ISO </a:t>
            </a:r>
            <a:r>
              <a:rPr lang="en-US" altLang="ko-KR" sz="1100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infusion (ISO).</a:t>
            </a:r>
            <a:endParaRPr lang="ko-KR" altLang="ko-KR" sz="1100" kern="100" dirty="0">
              <a:effectLst/>
              <a:latin typeface="Times New Roman" panose="02020603050405020304" pitchFamily="18" charset="0"/>
              <a:ea typeface="바탕체" panose="02030609000101010101" pitchFamily="17" charset="-127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35320" y="2771282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개체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6416469"/>
              </p:ext>
            </p:extLst>
          </p:nvPr>
        </p:nvGraphicFramePr>
        <p:xfrm>
          <a:off x="1559585" y="2716603"/>
          <a:ext cx="4084922" cy="404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35" name="Image" r:id="rId7" imgW="5828400" imgH="482400" progId="Photoshop.Image.13">
                  <p:embed/>
                </p:oleObj>
              </mc:Choice>
              <mc:Fallback>
                <p:oleObj name="Image" r:id="rId7" imgW="5828400" imgH="4824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>
                        <a:lum bright="20000"/>
                      </a:blip>
                      <a:stretch>
                        <a:fillRect/>
                      </a:stretch>
                    </p:blipFill>
                    <p:spPr>
                      <a:xfrm>
                        <a:off x="1559585" y="2716603"/>
                        <a:ext cx="4084922" cy="404337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390245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6</TotalTime>
  <Words>68</Words>
  <Application>Microsoft Office PowerPoint</Application>
  <PresentationFormat>A4 용지(210x297mm)</PresentationFormat>
  <Paragraphs>10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10" baseType="lpstr">
      <vt:lpstr>굴림</vt:lpstr>
      <vt:lpstr>맑은 고딕</vt:lpstr>
      <vt:lpstr>바탕체</vt:lpstr>
      <vt:lpstr>Arial</vt:lpstr>
      <vt:lpstr>Calibri</vt:lpstr>
      <vt:lpstr>Calibri Light</vt:lpstr>
      <vt:lpstr>Times New Roman</vt:lpstr>
      <vt:lpstr>Office 테마</vt:lpstr>
      <vt:lpstr>Image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대령</dc:creator>
  <cp:lastModifiedBy>Windows User</cp:lastModifiedBy>
  <cp:revision>225</cp:revision>
  <cp:lastPrinted>2014-07-29T08:24:50Z</cp:lastPrinted>
  <dcterms:created xsi:type="dcterms:W3CDTF">2014-05-21T07:45:37Z</dcterms:created>
  <dcterms:modified xsi:type="dcterms:W3CDTF">2016-01-30T02:33:28Z</dcterms:modified>
</cp:coreProperties>
</file>